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7" r:id="rId2"/>
    <p:sldId id="284" r:id="rId3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Emma Bastow (JIC)" initials="EB(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885"/>
    <a:srgbClr val="646464"/>
    <a:srgbClr val="5C5C5C"/>
    <a:srgbClr val="777777"/>
    <a:srgbClr val="757575"/>
    <a:srgbClr val="D07C7A"/>
    <a:srgbClr val="EEFFDD"/>
    <a:srgbClr val="CCFF99"/>
    <a:srgbClr val="DDE9F7"/>
    <a:srgbClr val="D1E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149" autoAdjust="0"/>
    <p:restoredTop sz="94660"/>
  </p:normalViewPr>
  <p:slideViewPr>
    <p:cSldViewPr>
      <p:cViewPr>
        <p:scale>
          <a:sx n="120" d="100"/>
          <a:sy n="120" d="100"/>
        </p:scale>
        <p:origin x="-1284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3076363" cy="511731"/>
          </a:xfrm>
          <a:prstGeom prst="rect">
            <a:avLst/>
          </a:prstGeom>
        </p:spPr>
        <p:txBody>
          <a:bodyPr vert="horz" lIns="94760" tIns="47380" rIns="94760" bIns="4738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6" y="1"/>
            <a:ext cx="3076363" cy="511731"/>
          </a:xfrm>
          <a:prstGeom prst="rect">
            <a:avLst/>
          </a:prstGeom>
        </p:spPr>
        <p:txBody>
          <a:bodyPr vert="horz" lIns="94760" tIns="47380" rIns="94760" bIns="47380" rtlCol="0"/>
          <a:lstStyle>
            <a:lvl1pPr algn="r">
              <a:defRPr sz="1200"/>
            </a:lvl1pPr>
          </a:lstStyle>
          <a:p>
            <a:fld id="{0B8996A4-32E6-444E-9466-653065370DD2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20913" y="768350"/>
            <a:ext cx="265747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0" tIns="47380" rIns="94760" bIns="4738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1" y="4861443"/>
            <a:ext cx="5679440" cy="4605576"/>
          </a:xfrm>
          <a:prstGeom prst="rect">
            <a:avLst/>
          </a:prstGeom>
        </p:spPr>
        <p:txBody>
          <a:bodyPr vert="horz" lIns="94760" tIns="47380" rIns="94760" bIns="4738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721107"/>
            <a:ext cx="3076363" cy="511731"/>
          </a:xfrm>
          <a:prstGeom prst="rect">
            <a:avLst/>
          </a:prstGeom>
        </p:spPr>
        <p:txBody>
          <a:bodyPr vert="horz" lIns="94760" tIns="47380" rIns="94760" bIns="4738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6" y="9721107"/>
            <a:ext cx="3076363" cy="511731"/>
          </a:xfrm>
          <a:prstGeom prst="rect">
            <a:avLst/>
          </a:prstGeom>
        </p:spPr>
        <p:txBody>
          <a:bodyPr vert="horz" lIns="94760" tIns="47380" rIns="94760" bIns="47380" rtlCol="0" anchor="b"/>
          <a:lstStyle>
            <a:lvl1pPr algn="r">
              <a:defRPr sz="1200"/>
            </a:lvl1pPr>
          </a:lstStyle>
          <a:p>
            <a:fld id="{4FE57AC1-7BB1-438A-856A-2642A37CF6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44729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327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66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6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6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0134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3962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3686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951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9508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758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154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2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976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669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46432-6D89-40AB-83F8-92A682A293A1}" type="datetimeFigureOut">
              <a:rPr lang="en-GB" smtClean="0"/>
              <a:t>04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8EC0D-E736-4052-84A8-C1E3942B6B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9440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7188400"/>
              </p:ext>
            </p:extLst>
          </p:nvPr>
        </p:nvGraphicFramePr>
        <p:xfrm>
          <a:off x="764704" y="1074876"/>
          <a:ext cx="5400600" cy="8558644"/>
        </p:xfrm>
        <a:graphic>
          <a:graphicData uri="http://schemas.openxmlformats.org/drawingml/2006/table">
            <a:tbl>
              <a:tblPr>
                <a:tableStyleId>{D7AC3CCA-C797-4891-BE02-D94E43425B78}</a:tableStyleId>
              </a:tblPr>
              <a:tblGrid>
                <a:gridCol w="836605"/>
                <a:gridCol w="2547771"/>
                <a:gridCol w="583312"/>
                <a:gridCol w="1432912"/>
              </a:tblGrid>
              <a:tr h="11682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kern="700" baseline="0" dirty="0">
                          <a:effectLst/>
                        </a:rPr>
                        <a:t>At </a:t>
                      </a:r>
                      <a:r>
                        <a:rPr lang="en-GB" sz="800" b="1" u="none" strike="noStrike" kern="700" baseline="0" dirty="0" smtClean="0">
                          <a:effectLst/>
                        </a:rPr>
                        <a:t>code (TAIR)</a:t>
                      </a:r>
                      <a:endParaRPr lang="en-GB" sz="800" b="1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kern="700" baseline="0" dirty="0" smtClean="0">
                          <a:effectLst/>
                        </a:rPr>
                        <a:t>Protein name</a:t>
                      </a:r>
                      <a:endParaRPr lang="en-GB" sz="800" b="1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u="none" strike="noStrike" kern="700" baseline="0" dirty="0" smtClean="0">
                          <a:effectLst/>
                        </a:rPr>
                        <a:t>Number of hits</a:t>
                      </a:r>
                      <a:endParaRPr lang="en-GB" sz="800" b="1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b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800" b="1" dirty="0" smtClean="0"/>
                        <a:t>Cellular localization</a:t>
                      </a:r>
                      <a:r>
                        <a:rPr lang="en-GB" sz="800" b="1" baseline="30000" dirty="0" smtClean="0"/>
                        <a:t>1</a:t>
                      </a:r>
                      <a:endParaRPr lang="en-GB" sz="800" b="1" baseline="30000" dirty="0" smtClean="0">
                        <a:latin typeface="+mn-lt"/>
                      </a:endParaRPr>
                    </a:p>
                  </a:txBody>
                  <a:tcPr marL="72000" marR="72000" marT="18000" marB="18000" anchor="b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2354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26S proteasome regulatory subunit, putative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, 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0480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40S ribosomal protein S17-4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262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utative phosphatidylinositol 4-kinase type 2-beta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5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83364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2G3975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putative methyltransferase PMT11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6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Extracellular,</a:t>
                      </a:r>
                      <a:r>
                        <a:rPr lang="en-GB" sz="700" u="none" strike="noStrike" baseline="0" dirty="0" smtClean="0">
                          <a:effectLst/>
                        </a:rPr>
                        <a:t> plasma membran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981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65620 or AT5G10540.1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err="1">
                          <a:effectLst/>
                        </a:rPr>
                        <a:t>organellar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 </a:t>
                      </a:r>
                      <a:r>
                        <a:rPr lang="en-GB" sz="700" u="none" strike="noStrike" kern="700" baseline="0" dirty="0" err="1">
                          <a:effectLst/>
                        </a:rPr>
                        <a:t>oligopeptidase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 A (TOP1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4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233657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(AT4G30350) or AT5G57710.1;</a:t>
                      </a:r>
                      <a:endParaRPr lang="en-GB" sz="700" b="0" i="0" u="none" strike="noStrike" kern="700" baseline="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double </a:t>
                      </a:r>
                      <a:r>
                        <a:rPr lang="en-GB" sz="700" u="none" strike="noStrike" kern="700" baseline="0" dirty="0" err="1">
                          <a:effectLst/>
                        </a:rPr>
                        <a:t>Clp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-N motif-containing P-loop nucleoside triphosphate hydrolases superfamily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protein (SMXL2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4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smtClean="0">
                          <a:effectLst/>
                        </a:rPr>
                        <a:t>AT1G60710</a:t>
                      </a:r>
                      <a:endParaRPr lang="en-GB" sz="700" b="0" i="0" u="none" strike="noStrike" kern="700" baseline="0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s-ES" sz="700" u="none" strike="noStrike" kern="700" baseline="0">
                          <a:effectLst/>
                        </a:rPr>
                        <a:t>probable aldo-keto reductase 4 (ATB2)</a:t>
                      </a:r>
                      <a:endParaRPr lang="es-ES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2480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basic leucine zipper 9 (BZIP9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283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ethylene-responsive transcription factor 11 (ERF11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0394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700" u="none" strike="noStrike" kern="700" baseline="0">
                          <a:effectLst/>
                        </a:rPr>
                        <a:t>chloroplast signal recognition particle 54 (CPSRP54)</a:t>
                      </a:r>
                      <a:endParaRPr lang="fr-FR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2280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robable alanine--tRNA ligase (EMB1030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6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2G0132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BC transporter G family member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7 (ABCG7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ma membran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18400</a:t>
                      </a:r>
                      <a:endParaRPr lang="en-GB" sz="700" b="1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err="1">
                          <a:effectLst/>
                        </a:rPr>
                        <a:t>anamorsin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 homolog (DRE2)</a:t>
                      </a:r>
                      <a:endParaRPr lang="en-GB" sz="700" b="1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, plasma membran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4G352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lant regulator RWP-RK family protein (F23E12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142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hosphatidylinositol-3P 5-kinase-like (FAB1B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4G3622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err="1">
                          <a:effectLst/>
                        </a:rPr>
                        <a:t>ferulic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 acid 5-hydroxylase 1 (FAH1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0412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glyceraldehyde-3-phosphate dehydrogenase C subunit (GAPC1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7953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glyceraldehyde-3-phosphate dehydrogenase (GAPCP1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5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1630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glyceraldehyde 3-phosphate dehydrogenase (GAPCP-2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1363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magnesium chelatase subunit H (GUN5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4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22425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Imidazoleglycerol-phosphate dehydratase 1 (IGPD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5104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succinate dehydrogenase assembly factor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2 (SDHAF2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Mitochondrio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6899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DNA-directed RNA polymerase 1, mitochondrial (MGP3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Mitochondrio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4G1272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nudix hydrolase 7 (NUDT7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eroxisom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0802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PHD finger-containing protein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>
                          <a:effectLst/>
                        </a:rPr>
                        <a:t>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5906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transcription factor PIF5 (PIL6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1534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roton pump interactor 2 (PPI2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665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S II oxygen-evolving complex 1 (PSBO1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4G3909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cysteine proteinase (RD19a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Vacuole, 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6203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eptidyl-prolyl cis-trans isomerase CYP20 (ROC4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2G4634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rotein SUPPRESSOR OF PHYA-105 (SPA1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0192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serine/threonine-protein kinase (STN8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0474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mediator of RNA polymerase II transcription subunit 14 (SWP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2G0579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O-glycosyl hydrolases family 17 protein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>
                          <a:effectLst/>
                        </a:rPr>
                        <a:t>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Extracellular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98120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5323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TEOSINTE BRANCHED 1, </a:t>
                      </a:r>
                      <a:r>
                        <a:rPr lang="en-GB" sz="700" u="none" strike="noStrike" kern="700" baseline="0" dirty="0" err="1">
                          <a:effectLst/>
                        </a:rPr>
                        <a:t>cycloidea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 and PCF transcription factor 3 (TCP3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1575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rotein TOPLESS (TPL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ma membrane, </a:t>
                      </a:r>
                      <a:r>
                        <a:rPr lang="en-GB" sz="700" u="none" strike="noStrike" dirty="0" err="1" smtClean="0">
                          <a:effectLst/>
                        </a:rPr>
                        <a:t>goli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2G474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rotein disulfide-isomerase like 2-1 (UNE5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Endoplasmic  reticulum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4G3020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vernalization5/VIN3-like protein (VEL1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6420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it-IT" sz="700" u="none" strike="noStrike" kern="700" baseline="0">
                          <a:effectLst/>
                        </a:rPr>
                        <a:t>V-type proton ATPase subunit E3 (VHA-E3)</a:t>
                      </a:r>
                      <a:endParaRPr lang="it-IT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Vacuol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2G384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putative WRKY transcription factor 33 (WRKY33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47128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cysteine proteinase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(RD21A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79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Vacuol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1939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err="1">
                          <a:effectLst/>
                        </a:rPr>
                        <a:t>Granulin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 repeat cysteine protease family protein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4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Vacuol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4306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err="1">
                          <a:effectLst/>
                        </a:rPr>
                        <a:t>Granulin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 repeat cysteine protease family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protein (RD21B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34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Vacuol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59124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putative disease resistance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protein 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eroxisom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2G2608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glycine decarboxylase P-protein 2 (GLDP2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Mitochondrion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4G1335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NSP (nuclear shuttle protein)-interacting </a:t>
                      </a:r>
                      <a:r>
                        <a:rPr lang="en-GB" sz="700" u="none" strike="noStrike" kern="700" baseline="0" dirty="0" err="1" smtClean="0">
                          <a:effectLst/>
                        </a:rPr>
                        <a:t>GTPase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 (NIG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, 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1646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err="1">
                          <a:effectLst/>
                        </a:rPr>
                        <a:t>jacalin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-like lectin domain-containing protein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50960</a:t>
                      </a:r>
                      <a:endParaRPr lang="en-GB" sz="700" b="1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nucleotide binding protein 35 (NBP35)</a:t>
                      </a:r>
                      <a:endParaRPr lang="en-GB" sz="700" b="1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4G3207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protein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(PHOX4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7301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>
                          <a:effectLst/>
                        </a:rPr>
                        <a:t>inorganic pyrophosphatase 1 (PS2)</a:t>
                      </a:r>
                      <a:endParaRPr lang="en-GB" sz="700" b="0" i="0" u="none" strike="noStrike" kern="700" baseline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Cytosol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4510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BOI-related protein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1 (BRG1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1G6709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ribulose bisphosphate carboxylase small chain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1A (RBCS1A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Plastid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3G6346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transport protein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(SEC31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>
                          <a:effectLst/>
                        </a:rPr>
                        <a:t>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dirty="0" smtClean="0">
                          <a:effectLst/>
                        </a:rPr>
                        <a:t>Nucleus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  <a:tr h="116828"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>
                          <a:effectLst/>
                        </a:rPr>
                        <a:t>AT5G10540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err="1">
                          <a:effectLst/>
                        </a:rPr>
                        <a:t>zincin</a:t>
                      </a:r>
                      <a:r>
                        <a:rPr lang="en-GB" sz="700" u="none" strike="noStrike" kern="700" baseline="0" dirty="0">
                          <a:effectLst/>
                        </a:rPr>
                        <a:t>-like metalloproteases family </a:t>
                      </a:r>
                      <a:r>
                        <a:rPr lang="en-GB" sz="700" u="none" strike="noStrike" kern="700" baseline="0" dirty="0" smtClean="0">
                          <a:effectLst/>
                        </a:rPr>
                        <a:t>protein (TOP2)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smtClean="0">
                          <a:effectLst/>
                        </a:rPr>
                        <a:t>21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700" u="none" strike="noStrike" kern="700" baseline="0" dirty="0" smtClean="0">
                          <a:effectLst/>
                        </a:rPr>
                        <a:t>Cytosol</a:t>
                      </a:r>
                      <a:endParaRPr lang="en-GB" sz="700" b="0" i="0" u="none" strike="noStrike" kern="700" baseline="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000" marR="72000" marT="18000" marB="18000" anchor="ctr">
                    <a:noFill/>
                  </a:tcPr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692696" y="9664878"/>
            <a:ext cx="5400600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600" dirty="0"/>
              <a:t>1= based on SUBA3 consensus (suba3.plantenergy.uwa.edu.au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92696" y="570820"/>
            <a:ext cx="547260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Table S1. </a:t>
            </a:r>
            <a:r>
              <a:rPr lang="en-GB" sz="1100" dirty="0" smtClean="0"/>
              <a:t>Yeast-2-hybrid interactions of Arabidopsis NBP35 screened against a fragment library of seedling cDNA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504446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2412506"/>
              </p:ext>
            </p:extLst>
          </p:nvPr>
        </p:nvGraphicFramePr>
        <p:xfrm>
          <a:off x="706561" y="852636"/>
          <a:ext cx="5386735" cy="4737600"/>
        </p:xfrm>
        <a:graphic>
          <a:graphicData uri="http://schemas.openxmlformats.org/drawingml/2006/table">
            <a:tbl>
              <a:tblPr firstRow="1" firstCol="1" bandRow="1">
                <a:tableStyleId>{D7AC3CCA-C797-4891-BE02-D94E43425B78}</a:tableStyleId>
              </a:tblPr>
              <a:tblGrid>
                <a:gridCol w="475779"/>
                <a:gridCol w="987083"/>
                <a:gridCol w="3923873"/>
              </a:tblGrid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Name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Prime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Sequence 5’-3’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MDR1-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TCCGTTTTAGGCTTAGGACC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MDR1-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AAAACATTTCTAGCACAAAGAAA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RNAi-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ATTCTAGACTCGAGTTGTTGATGCCCCACCA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RNAi-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ACTGAATTCATCGATGGAGACTTCCTGCGGTGT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XBAT34-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TTTGAAGCATATCTCCTCTAT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 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XBAT34-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AGGTCGTTATTTGTTCATCGGT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EB1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14A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CAGAGGACGCTAACGAGCATGCCCCAGGTCCTC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2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14A_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AGGACCTGGGGCATGCTCGTTAGCGTCCTCTG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13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BP35prom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TCGGCGCGCCATCCCTAAATCTTTGCTTTA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15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BP35prom_R2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TCTCCATGGCGTCGACTTGAGACTTCTC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16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UBQ11prom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ATGGCGCGCCGCAGTGTGATACTGAT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18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UBQ11prom_ R2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AGCCATGGCTCGAGCTGTTAATCAGAAA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21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BP35exon2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GATTCTTGTGCTGGCTGCCC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22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BP35exon3_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TATGGACATGACACCAAG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EB27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BP35intron1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TTGGGTTTTGTTCTTTGGTTGCT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28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NBP35intron2_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TCAAACACATCTGGCGCTT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31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L2-UTF (P1)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TCATCCTCTCTGCTATGGCAAC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32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L2-R1 (P3)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TCAACCATCGCATATTCGCC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59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wFLNBP35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AAGTTTGTACAAAAAAGCAGGCTTCATGGAGAACGGAGACATT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0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wFLNBP35_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CACTTTGTACAAGAAAGCTGGGTCTCACTCGGTCATCACTGT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1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wFLDRE2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AAGTTTGTACAAAAAAGCAGGCTTCATGGATTCGATGATGAAT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2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wFLDRE2_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CACTTTGTACAAGAAAGCTGGGTCTTATATGTCAGCTTCAA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3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wFLTAH18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AAGTTTGTACAAAAAAGCAGGCTTCATGGGAGAAAAACAAAG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4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gwFLTAH18_R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CACTTTGTACAAGAAAGCTGGGTCTTAAGACCAAGCTTCAAC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5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wFLNAR1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AAGTTTGTACAAAAAAGCAGGCTTCATGTCAGAGAAGTTTTCA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6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wFLNAR1_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GGGACCACTTTGTACAAGAAAGCTGGGTCCTACCAGTTGTTGAGCT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69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pASK_F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GAGTTATTTTACCACTCCCT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70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pASK_R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CGCAGTAGCGGTAAACG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</a:rPr>
                        <a:t>EB77</a:t>
                      </a:r>
                      <a:endParaRPr lang="en-GB" sz="80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LBb1.3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</a:rPr>
                        <a:t>ATTTTGCCGATTTCGGAAC</a:t>
                      </a:r>
                      <a:endParaRPr lang="en-GB" sz="800" dirty="0">
                        <a:effectLst/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72000" marR="72000" marT="18000" marB="18000">
                    <a:noFill/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20688" y="560512"/>
            <a:ext cx="5400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Table S2. </a:t>
            </a:r>
            <a:r>
              <a:rPr lang="en-GB" sz="1100" dirty="0" smtClean="0"/>
              <a:t>Primer list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5704559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7</TotalTime>
  <Words>686</Words>
  <Application>Microsoft Office PowerPoint</Application>
  <PresentationFormat>A4 Paper (210x297 mm)</PresentationFormat>
  <Paragraphs>31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NB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neke Balk (JIC)</dc:creator>
  <cp:lastModifiedBy>Janneke Balk (JIC)</cp:lastModifiedBy>
  <cp:revision>189</cp:revision>
  <cp:lastPrinted>2016-08-19T13:08:39Z</cp:lastPrinted>
  <dcterms:created xsi:type="dcterms:W3CDTF">2012-03-08T11:29:39Z</dcterms:created>
  <dcterms:modified xsi:type="dcterms:W3CDTF">2016-10-04T14:15:24Z</dcterms:modified>
</cp:coreProperties>
</file>